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2" r:id="rId4"/>
    <p:sldId id="290" r:id="rId5"/>
    <p:sldId id="283" r:id="rId6"/>
    <p:sldId id="276" r:id="rId7"/>
    <p:sldId id="284" r:id="rId8"/>
    <p:sldId id="285" r:id="rId9"/>
    <p:sldId id="291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64" d="100"/>
          <a:sy n="64" d="100"/>
        </p:scale>
        <p:origin x="756" y="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F74B9-AA1A-4043-9A4E-9C872A38E8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10375A-9A61-48E2-BE08-C02510D039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4EFD86-7C8B-4C12-968D-112067070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A37B3B-8DAD-403A-B1FC-1A6C4647B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0E7742-6324-4D3D-8899-FA92363CE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67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FF4F9-AD79-41E3-B4E1-2FAB9E4A9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390509-1307-477F-B3D8-1C2084D90C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8002ED-032B-49F8-960C-DAB00F2AA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20023B-B926-434A-86C6-27CF4A2DE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4E89CB-641E-4C11-A886-EB965E393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274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961C6C-52C9-43E5-A50B-64E587AA3C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D15889-C83A-4714-9D49-604B335D06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3271BA-1D57-46FC-BC07-BC79689E0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19A64A-DB2A-48AA-B93B-F16ED01C6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38185F-221A-436E-AE09-D78009D70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961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22BC3-6630-47A1-BE47-623930EFE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14AC7D-2747-4E92-AE9F-30FEBC9803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AE61DB-161C-45AD-A035-34D0BF4D2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B58412-EC3E-4500-8C29-964D1BECE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C814CF-7E70-4529-A78C-69360A428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13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C531D-23FA-43D6-B9F7-C65CA9EA2E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C11F1D-CBA3-44D2-B011-143A62841A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F8116-57DF-415E-9457-92E8E11C8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0F6FA3-E8A8-427A-B974-E9743C4FB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1D5E5-A423-463C-A2D8-8338F5518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174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120F9-96C7-4197-9F54-D7BE8AD65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2E700E-46B7-461D-A74C-42E52F469C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237CBD-3533-45A1-97D7-CCFF48C43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4611CF-9871-48C2-B15C-7E06D5B27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F8038C-E0DC-4EEA-BA46-A6476208D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D32BA0-0038-474F-A341-A3794AB3D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682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455A6-2E54-466C-A38C-7F7EFCA1F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044DDB-168E-4DE9-9E22-891BC44718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58B725-D7E5-4E1E-BCB1-356C1FBB70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3E7CB6-27FA-4482-98E0-49CF388A3A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C665C2-EF65-4057-A97E-393654AB60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85DFD7-0F8C-42C3-8EBE-7510361F6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968848-B6E7-4099-A881-16A2D7D62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72C74F-43AF-42BF-94E3-157FB6C00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715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82530-DBB8-4ABC-913E-B318316E6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5BCA75-D234-4F02-896F-174A4C6F9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E3B34C-64BB-4163-89FF-4FA9F271C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14758C-BBC1-4126-A681-B55BE1D71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20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79025A-EF2B-4DDE-B880-811879A43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C924ED-CD40-4A3B-ACE1-5764C12DC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E7672A-6F9A-48CE-A80C-97DF5662B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84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496A3-FF45-498B-9755-34526CCFF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65E3FD-E214-403D-8A8F-1C460C4C38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94892C-3164-48DF-B72A-3A325720CF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BA9094-C13B-4507-B2BD-9073144DB5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D6999-7C00-47F5-BEBD-208F6B524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FF8C49-C868-4C20-9D4B-1E630A0C1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78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173DB-BED6-42EF-B44E-487CA1391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9F2E6D-CC8A-4AB7-8CF6-DAC186FC84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DF9B87-E0B0-4F81-92D5-6A9083DE96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E38E9C-D3D7-4B59-83E3-93D6DC392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13B52F-236A-416B-932F-96745C7E3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C0FEFE-C823-4397-AC19-8A4DB030D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485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88E09C2-07DF-40B1-B680-F84B648625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584A52-1671-43D5-A749-B5B4E4BE5E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BACE89-8CB3-45E5-86F3-2B69544988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40FED-96BB-4C58-BAE9-FF799B3887DF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9781A-0198-4235-BEA2-6962E70E04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E5650F-8EE0-40B0-906B-189AF171A8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273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FFEE01-BF6D-43D0-ABE2-71C7579250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CBC 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 </a:t>
            </a:r>
          </a:p>
          <a:p>
            <a:pPr marL="0" indent="0">
              <a:buNone/>
            </a:pPr>
            <a:r>
              <a:rPr lang="en-US" sz="4400" dirty="0"/>
              <a:t>WBC: 9.3 x 1000/mm</a:t>
            </a:r>
            <a:r>
              <a:rPr lang="en-US" sz="4400" baseline="30000" dirty="0"/>
              <a:t>3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HGB: 14.0 g/dL</a:t>
            </a:r>
          </a:p>
          <a:p>
            <a:pPr marL="0" indent="0">
              <a:buNone/>
            </a:pPr>
            <a:r>
              <a:rPr lang="en-US" sz="4400" dirty="0"/>
              <a:t>HCT: 41.7%</a:t>
            </a:r>
          </a:p>
          <a:p>
            <a:pPr marL="0" indent="0">
              <a:buNone/>
            </a:pPr>
            <a:r>
              <a:rPr lang="en-US" sz="4400" dirty="0"/>
              <a:t>PLT: 380 x 1000/mm</a:t>
            </a:r>
            <a:r>
              <a:rPr lang="en-US" sz="4400" baseline="30000" dirty="0"/>
              <a:t>3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Bands: 5%</a:t>
            </a:r>
          </a:p>
        </p:txBody>
      </p:sp>
    </p:spTree>
    <p:extLst>
      <p:ext uri="{BB962C8B-B14F-4D97-AF65-F5344CB8AC3E}">
        <p14:creationId xmlns:p14="http://schemas.microsoft.com/office/powerpoint/2010/main" val="13777860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28A90-5768-4105-998C-BA5664805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15410"/>
            <a:ext cx="10515600" cy="5418821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3600" b="1" dirty="0"/>
              <a:t>BMP </a:t>
            </a:r>
            <a:endParaRPr lang="en-US" sz="3600" dirty="0"/>
          </a:p>
          <a:p>
            <a:pPr marL="0" indent="0">
              <a:buNone/>
            </a:pPr>
            <a:r>
              <a:rPr lang="en-US" sz="3600" dirty="0"/>
              <a:t> </a:t>
            </a:r>
          </a:p>
          <a:p>
            <a:pPr marL="0" indent="0">
              <a:buNone/>
            </a:pPr>
            <a:r>
              <a:rPr lang="en-US" sz="3600" dirty="0"/>
              <a:t>Na 140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Cl 99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K 4.0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HCO3 22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BUN 20 mg/dL</a:t>
            </a:r>
          </a:p>
          <a:p>
            <a:pPr marL="0" indent="0">
              <a:buNone/>
            </a:pPr>
            <a:r>
              <a:rPr lang="en-US" sz="3600" dirty="0"/>
              <a:t>Cr 0.9 mg/dL</a:t>
            </a:r>
          </a:p>
          <a:p>
            <a:pPr marL="0" indent="0">
              <a:buNone/>
            </a:pPr>
            <a:r>
              <a:rPr lang="en-US" sz="3600" dirty="0" err="1"/>
              <a:t>Gluc</a:t>
            </a:r>
            <a:r>
              <a:rPr lang="en-US" sz="3600" dirty="0"/>
              <a:t> 90 mg/dL</a:t>
            </a:r>
          </a:p>
          <a:p>
            <a:pPr marL="0" indent="0">
              <a:buNone/>
            </a:pPr>
            <a:r>
              <a:rPr lang="en-US" sz="3600" dirty="0"/>
              <a:t>Calcium 8.0 mg/dL</a:t>
            </a: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5952733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28A90-5768-4105-998C-BA5664805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79944"/>
            <a:ext cx="10515600" cy="5418821"/>
          </a:xfrm>
        </p:spPr>
        <p:txBody>
          <a:bodyPr>
            <a:noAutofit/>
          </a:bodyPr>
          <a:lstStyle/>
          <a:p>
            <a:pPr marL="0" indent="0">
              <a:buNone/>
            </a:pPr>
            <a:endParaRPr lang="en-US" sz="4400" b="1" dirty="0"/>
          </a:p>
          <a:p>
            <a:pPr marL="0" indent="0">
              <a:buNone/>
            </a:pPr>
            <a:r>
              <a:rPr lang="en-US" sz="4400" b="1" dirty="0"/>
              <a:t>Troponin</a:t>
            </a:r>
          </a:p>
          <a:p>
            <a:pPr marL="0" indent="0">
              <a:buNone/>
            </a:pPr>
            <a:r>
              <a:rPr lang="en-US" sz="4400" dirty="0"/>
              <a:t> </a:t>
            </a:r>
          </a:p>
          <a:p>
            <a:pPr marL="0" indent="0">
              <a:buNone/>
            </a:pPr>
            <a:r>
              <a:rPr lang="en-US" sz="4400" dirty="0"/>
              <a:t>0.03 ng/mL</a:t>
            </a:r>
          </a:p>
          <a:p>
            <a:pPr marL="0" indent="0">
              <a:buNone/>
            </a:pP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1267876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28A90-5768-4105-998C-BA5664805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79944"/>
            <a:ext cx="10515600" cy="5418821"/>
          </a:xfrm>
        </p:spPr>
        <p:txBody>
          <a:bodyPr>
            <a:noAutofit/>
          </a:bodyPr>
          <a:lstStyle/>
          <a:p>
            <a:pPr marL="0" indent="0">
              <a:buNone/>
            </a:pPr>
            <a:endParaRPr lang="en-US" sz="4400" b="1" dirty="0"/>
          </a:p>
          <a:p>
            <a:pPr marL="0" indent="0">
              <a:buNone/>
            </a:pPr>
            <a:r>
              <a:rPr lang="en-US" sz="4400" b="1" dirty="0"/>
              <a:t>BNP</a:t>
            </a:r>
          </a:p>
          <a:p>
            <a:pPr marL="0" indent="0">
              <a:buNone/>
            </a:pPr>
            <a:r>
              <a:rPr lang="en-US" sz="4400" dirty="0"/>
              <a:t> </a:t>
            </a:r>
          </a:p>
          <a:p>
            <a:pPr marL="0" indent="0">
              <a:buNone/>
            </a:pPr>
            <a:r>
              <a:rPr lang="en-US" sz="4400" dirty="0"/>
              <a:t>86 </a:t>
            </a:r>
            <a:r>
              <a:rPr lang="en-US" sz="4400" dirty="0" err="1"/>
              <a:t>pg</a:t>
            </a:r>
            <a:r>
              <a:rPr lang="en-US" sz="4400" dirty="0"/>
              <a:t>/mL</a:t>
            </a:r>
          </a:p>
          <a:p>
            <a:pPr marL="0" indent="0">
              <a:buNone/>
            </a:pP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31652781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0D6906-5E5C-4F4C-9E0F-7EEC3AA912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0705" y="684828"/>
            <a:ext cx="10515600" cy="549963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PT/INR</a:t>
            </a:r>
          </a:p>
          <a:p>
            <a:pPr marL="0" indent="0">
              <a:buNone/>
            </a:pPr>
            <a:endParaRPr lang="en-US" sz="4400" dirty="0"/>
          </a:p>
          <a:p>
            <a:pPr marL="0" indent="0">
              <a:buNone/>
            </a:pPr>
            <a:r>
              <a:rPr lang="en-US" sz="4400" dirty="0"/>
              <a:t>22.5 sec/2.1</a:t>
            </a:r>
          </a:p>
        </p:txBody>
      </p:sp>
    </p:spTree>
    <p:extLst>
      <p:ext uri="{BB962C8B-B14F-4D97-AF65-F5344CB8AC3E}">
        <p14:creationId xmlns:p14="http://schemas.microsoft.com/office/powerpoint/2010/main" val="7398451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68794265-C876-48CD-906C-383AB222BF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1877" y="245908"/>
            <a:ext cx="8488245" cy="63661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616455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">
            <a:extLst>
              <a:ext uri="{FF2B5EF4-FFF2-40B4-BE49-F238E27FC236}">
                <a16:creationId xmlns:a16="http://schemas.microsoft.com/office/drawing/2014/main" id="{93E8CC19-4B92-49B4-A5A2-57ED200C5D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267" y="1134533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Rectangle 3">
            <a:extLst>
              <a:ext uri="{FF2B5EF4-FFF2-40B4-BE49-F238E27FC236}">
                <a16:creationId xmlns:a16="http://schemas.microsoft.com/office/drawing/2014/main" id="{5B1A0163-CE92-435A-AEED-E982A883F1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267" y="5447771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1F1CE70-A729-4405-8447-A5BD06DACDFB}"/>
              </a:ext>
            </a:extLst>
          </p:cNvPr>
          <p:cNvSpPr txBox="1"/>
          <p:nvPr/>
        </p:nvSpPr>
        <p:spPr>
          <a:xfrm>
            <a:off x="5655365" y="251460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kern="120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wo</a:t>
            </a:r>
            <a:r>
              <a:rPr lang="en-US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voltage </a:t>
            </a:r>
            <a:r>
              <a:rPr lang="en-US" sz="1800" kern="120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ecg</a:t>
            </a:r>
            <a:endParaRPr 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2052" name="Picture 4">
            <a:extLst>
              <a:ext uri="{FF2B5EF4-FFF2-40B4-BE49-F238E27FC236}">
                <a16:creationId xmlns:a16="http://schemas.microsoft.com/office/drawing/2014/main" id="{5663C0B8-160A-48B0-938C-A0DAC435B8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451" y="111608"/>
            <a:ext cx="12880939" cy="67463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228923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507B86-03F3-48B4-8B0B-885DEDA8A9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098" name="Picture 2">
            <a:extLst>
              <a:ext uri="{FF2B5EF4-FFF2-40B4-BE49-F238E27FC236}">
                <a16:creationId xmlns:a16="http://schemas.microsoft.com/office/drawing/2014/main" id="{2F03C5FD-E2B6-4B87-957C-A38AE877F2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4583" y="430788"/>
            <a:ext cx="10422834" cy="61852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358153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FC90F4-0D12-472F-91C0-F2BF7921E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7F2C64-9034-44D6-9292-399C4F24CC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D23E8E2A-FBEC-4AC3-8266-4456CC41B0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9712" y="101876"/>
            <a:ext cx="8756375" cy="65672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9699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1</TotalTime>
  <Words>94</Words>
  <Application>Microsoft Office PowerPoint</Application>
  <PresentationFormat>Widescreen</PresentationFormat>
  <Paragraphs>2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Yee</dc:creator>
  <cp:lastModifiedBy>Jennifer Yee</cp:lastModifiedBy>
  <cp:revision>121</cp:revision>
  <dcterms:created xsi:type="dcterms:W3CDTF">2017-07-27T19:07:38Z</dcterms:created>
  <dcterms:modified xsi:type="dcterms:W3CDTF">2020-06-30T05:04:47Z</dcterms:modified>
</cp:coreProperties>
</file>